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7A3DC-4AE2-4E6A-9996-C717B6D00C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8871AB-5DB6-46CA-A299-9C3745D0CD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17F2B3-C445-48CC-B6B7-0FCD0E5D00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24377A-1539-4321-A8FC-83EAA67B1C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27267-A519-473A-89CB-BD1E62F14A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6BEFC8-1EC5-4DF3-83C6-DBA7E296E4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4E0AF8-3406-4F69-B9C0-97D9A74663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D5E4A-F5D8-479F-B67D-9250A27E69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955AAB-43D6-44D2-9033-D8C67A2C10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A8610-5519-4BA5-AE3F-997DE5B524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AEE7E-3DCB-45EE-AC07-FA33EA8453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6B477-8E32-4290-B970-D5A81B527A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4FEEC68-AA58-42E7-81E4-77A782F7FFD9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2.wmf"/><Relationship Id="rId4" Type="http://schemas.openxmlformats.org/officeDocument/2006/relationships/image" Target="../media/image3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1222200" y="250920"/>
            <a:ext cx="2000520" cy="1704960"/>
          </a:xfrm>
          <a:prstGeom prst="rect">
            <a:avLst/>
          </a:prstGeom>
          <a:ln w="0">
            <a:noFill/>
          </a:ln>
        </p:spPr>
      </p:pic>
      <p:sp>
        <p:nvSpPr>
          <p:cNvPr id="42" name="テキスト ボックス 6"/>
          <p:cNvSpPr/>
          <p:nvPr/>
        </p:nvSpPr>
        <p:spPr>
          <a:xfrm>
            <a:off x="7560" y="8831160"/>
            <a:ext cx="1104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46"/>
          <p:cNvSpPr/>
          <p:nvPr/>
        </p:nvSpPr>
        <p:spPr>
          <a:xfrm>
            <a:off x="0" y="205092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54"/>
          <p:cNvSpPr/>
          <p:nvPr/>
        </p:nvSpPr>
        <p:spPr>
          <a:xfrm>
            <a:off x="314280" y="2197080"/>
            <a:ext cx="909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LINE-1 density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61"/>
          <p:cNvSpPr/>
          <p:nvPr/>
        </p:nvSpPr>
        <p:spPr>
          <a:xfrm>
            <a:off x="293760" y="2689200"/>
            <a:ext cx="928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Genes 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4q32.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グループ化 64"/>
          <p:cNvGrpSpPr/>
          <p:nvPr/>
        </p:nvGrpSpPr>
        <p:grpSpPr>
          <a:xfrm>
            <a:off x="1057320" y="2244600"/>
            <a:ext cx="5108400" cy="903240"/>
            <a:chOff x="1057320" y="2244600"/>
            <a:chExt cx="5108400" cy="903240"/>
          </a:xfrm>
        </p:grpSpPr>
        <p:sp>
          <p:nvSpPr>
            <p:cNvPr id="47" name="テキスト ボックス 48"/>
            <p:cNvSpPr/>
            <p:nvPr/>
          </p:nvSpPr>
          <p:spPr>
            <a:xfrm>
              <a:off x="4852440" y="2606760"/>
              <a:ext cx="1313280" cy="505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Arial"/>
                  <a:ea typeface="Arial"/>
                </a:rPr>
                <a:t>Immunoglobulin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Arial"/>
                  <a:ea typeface="Arial"/>
                </a:rPr>
                <a:t>heavy locu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0000"/>
                  </a:solidFill>
                  <a:latin typeface="Arial"/>
                  <a:ea typeface="Arial"/>
                </a:rPr>
                <a:t>(IGH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左大かっこ 66"/>
            <p:cNvSpPr/>
            <p:nvPr/>
          </p:nvSpPr>
          <p:spPr>
            <a:xfrm rot="16200000">
              <a:off x="5244840" y="1856880"/>
              <a:ext cx="56880" cy="1454040"/>
            </a:xfrm>
            <a:custGeom>
              <a:avLst/>
              <a:gdLst>
                <a:gd name="textAreaLeft" fmla="*/ 16560 w 56880"/>
                <a:gd name="textAreaRight" fmla="*/ 57240 w 56880"/>
                <a:gd name="textAreaTop" fmla="*/ 0 h 1454040"/>
                <a:gd name="textAreaBottom" fmla="*/ 1454400 h 14540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0"/>
                    <a:pt x="0" y="0"/>
                  </a:cubicBezTo>
                  <a:lnTo>
                    <a:pt x="0" y="21600"/>
                  </a:lnTo>
                  <a:cubicBezTo>
                    <a:pt x="0" y="21600"/>
                    <a:pt x="10800" y="21600"/>
                    <a:pt x="21600" y="21600"/>
                  </a:cubicBezTo>
                </a:path>
              </a:pathLst>
            </a:custGeom>
            <a:noFill/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9" name="Picture 1" descr=""/>
            <p:cNvPicPr/>
            <p:nvPr/>
          </p:nvPicPr>
          <p:blipFill>
            <a:blip r:embed="rId2"/>
            <a:srcRect l="56626" t="0" r="0" b="0"/>
            <a:stretch/>
          </p:blipFill>
          <p:spPr>
            <a:xfrm rot="16200000">
              <a:off x="3383640" y="-81720"/>
              <a:ext cx="248400" cy="4901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1" descr=""/>
            <p:cNvPicPr/>
            <p:nvPr/>
          </p:nvPicPr>
          <p:blipFill>
            <a:blip r:embed="rId3"/>
            <a:srcRect l="0" t="0" r="47177" b="0"/>
            <a:stretch/>
          </p:blipFill>
          <p:spPr>
            <a:xfrm rot="16200000">
              <a:off x="3228840" y="417960"/>
              <a:ext cx="558000" cy="49014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1" name="グループ化 63"/>
          <p:cNvGrpSpPr/>
          <p:nvPr/>
        </p:nvGrpSpPr>
        <p:grpSpPr>
          <a:xfrm>
            <a:off x="3492360" y="468360"/>
            <a:ext cx="3249360" cy="882720"/>
            <a:chOff x="3492360" y="468360"/>
            <a:chExt cx="3249360" cy="882720"/>
          </a:xfrm>
        </p:grpSpPr>
        <p:pic>
          <p:nvPicPr>
            <p:cNvPr id="52" name="Picture 3" descr=""/>
            <p:cNvPicPr/>
            <p:nvPr/>
          </p:nvPicPr>
          <p:blipFill>
            <a:blip r:embed="rId4"/>
            <a:srcRect l="0" t="0" r="0" b="34593"/>
            <a:stretch/>
          </p:blipFill>
          <p:spPr>
            <a:xfrm>
              <a:off x="4565520" y="636120"/>
              <a:ext cx="2176200" cy="714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テキスト ボックス 73"/>
            <p:cNvSpPr/>
            <p:nvPr/>
          </p:nvSpPr>
          <p:spPr>
            <a:xfrm>
              <a:off x="3814560" y="727200"/>
              <a:ext cx="938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GH locu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テキスト ボックス 74"/>
            <p:cNvSpPr/>
            <p:nvPr/>
          </p:nvSpPr>
          <p:spPr>
            <a:xfrm>
              <a:off x="3605040" y="1090800"/>
              <a:ext cx="11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her loc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テキスト ボックス 64"/>
            <p:cNvSpPr/>
            <p:nvPr/>
          </p:nvSpPr>
          <p:spPr>
            <a:xfrm>
              <a:off x="3492360" y="468360"/>
              <a:ext cx="1027080" cy="246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4q32.3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左大かっこ 76"/>
            <p:cNvSpPr/>
            <p:nvPr/>
          </p:nvSpPr>
          <p:spPr>
            <a:xfrm>
              <a:off x="3946320" y="716040"/>
              <a:ext cx="80640" cy="567000"/>
            </a:xfrm>
            <a:custGeom>
              <a:avLst/>
              <a:gdLst>
                <a:gd name="textAreaLeft" fmla="*/ 23760 w 80640"/>
                <a:gd name="textAreaRight" fmla="*/ 81000 w 80640"/>
                <a:gd name="textAreaTop" fmla="*/ 0 h 567000"/>
                <a:gd name="textAreaBottom" fmla="*/ 567360 h 5670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0"/>
                    <a:pt x="0" y="0"/>
                  </a:cubicBezTo>
                  <a:lnTo>
                    <a:pt x="0" y="21600"/>
                  </a:lnTo>
                  <a:cubicBezTo>
                    <a:pt x="0" y="21600"/>
                    <a:pt x="10800" y="21600"/>
                    <a:pt x="2160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右大かっこ 77"/>
            <p:cNvSpPr/>
            <p:nvPr/>
          </p:nvSpPr>
          <p:spPr>
            <a:xfrm>
              <a:off x="6519960" y="809640"/>
              <a:ext cx="64800" cy="415800"/>
            </a:xfrm>
            <a:custGeom>
              <a:avLst/>
              <a:gdLst>
                <a:gd name="textAreaLeft" fmla="*/ 0 w 64800"/>
                <a:gd name="textAreaRight" fmla="*/ 45360 w 64800"/>
                <a:gd name="textAreaTop" fmla="*/ 0 h 415800"/>
                <a:gd name="textAreaBottom" fmla="*/ 416160 h 4158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10800" y="0"/>
                    <a:pt x="21600" y="0"/>
                    <a:pt x="21600" y="0"/>
                  </a:cubicBezTo>
                  <a:lnTo>
                    <a:pt x="21600" y="21600"/>
                  </a:lnTo>
                  <a:cubicBezTo>
                    <a:pt x="21600" y="21600"/>
                    <a:pt x="108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テキスト ボックス 78"/>
            <p:cNvSpPr/>
            <p:nvPr/>
          </p:nvSpPr>
          <p:spPr>
            <a:xfrm rot="5400000">
              <a:off x="6424920" y="897840"/>
              <a:ext cx="387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**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テキスト ボックス 56"/>
          <p:cNvSpPr/>
          <p:nvPr/>
        </p:nvSpPr>
        <p:spPr>
          <a:xfrm>
            <a:off x="0" y="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88"/>
          <p:cNvSpPr/>
          <p:nvPr/>
        </p:nvSpPr>
        <p:spPr>
          <a:xfrm>
            <a:off x="44280" y="868320"/>
            <a:ext cx="1281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istribution of Alu  density acros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he whole genom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90"/>
          <p:cNvSpPr/>
          <p:nvPr/>
        </p:nvSpPr>
        <p:spPr>
          <a:xfrm>
            <a:off x="125280" y="468360"/>
            <a:ext cx="1195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BPs (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=8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84"/>
          <p:cNvSpPr/>
          <p:nvPr/>
        </p:nvSpPr>
        <p:spPr>
          <a:xfrm>
            <a:off x="264960" y="1508040"/>
            <a:ext cx="12574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Alu density</a:t>
            </a:r>
            <a:r>
              <a:rPr b="1" lang="ja-JP" sz="9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per 100000 b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テキスト ボックス 56"/>
          <p:cNvSpPr/>
          <p:nvPr/>
        </p:nvSpPr>
        <p:spPr>
          <a:xfrm>
            <a:off x="3367080" y="0"/>
            <a:ext cx="30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8T01:53:55Z</dcterms:created>
  <dc:creator>MN2010</dc:creator>
  <dc:description/>
  <dc:language>en-US</dc:language>
  <cp:lastModifiedBy>MN2010</cp:lastModifiedBy>
  <dcterms:modified xsi:type="dcterms:W3CDTF">2012-12-14T01:22:51Z</dcterms:modified>
  <cp:revision>1158</cp:revision>
  <dc:subject/>
  <dc:title>スライド 1</dc:title>
</cp:coreProperties>
</file>